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48" d="100"/>
          <a:sy n="48" d="100"/>
        </p:scale>
        <p:origin x="1578" y="5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E0394-4273-4BCE-A765-6AEBFE65E3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D35F7F-C6EC-45C9-8686-54001FE928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997741-FE7B-45ED-B88B-EEE0C9D9A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39BF53-5446-4440-AB1A-3540352C4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C6D5C-C7E7-41E5-B6CE-36795D13C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56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315554-407A-4C1E-9568-6D4216938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504121-B719-4EF9-A68C-FCD4A9DD89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0F2FEC-799C-4811-8F33-22BFDBE94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237755-0C10-4917-911C-930CE2D37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C325C-1526-4E13-8524-1ADEFAB7F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033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53DD67-9922-4577-AC7D-BAF1A2F4B0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B54566-F496-4C81-BC16-DA748D61AA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D8457-EB0A-4126-A7DF-7870D4887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FAF6F-74FD-48AB-B009-8E5AD775F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4512D-0ADB-4FCB-BA70-EAAF27340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889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550400-4B38-4A40-A3BA-6BC0DDD97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E6115C-78EC-4F43-A0D9-753D6DBC0F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EFBB99-8AA0-49F3-9DC9-934C88F79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E65572-25DD-4D21-8D0F-82A52A1F3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DD04F4-73AD-498F-A416-862BF5833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551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CFAE1-BA87-4A90-9DAC-89BE4FAA3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E97EEE-7723-4DCD-9938-4C87E442B7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18A1B0-ABFD-4245-83A3-3767C9197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72D435-6D27-4B2D-8CD0-7DF32BB98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3A2D1-85C8-40C3-8A50-00F5D00CC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441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3BFEE6-A62D-4CE2-8378-6BE5A56B8C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4DEA97-6C44-4C40-B7E7-14AB87721C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02CA88-5EFE-40FF-962E-847406EC4D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8E8F8A-652B-4BF6-80F5-64834E1C8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3CFEEC-E900-45E6-8051-5D4D18431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213ED3-3AD6-441D-ACE7-C850284DB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841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71A09-4711-47E3-BC77-AA81ADBA1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F449A-642C-420A-B68E-B2B458C2F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50EF9E-3080-491E-952F-0168AC409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2E31F8-8EAA-49DB-861A-CF784F484A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4E6EE2-F886-4AF2-96F8-B742DA1779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F32FB9-E70B-40D9-850E-53E180F8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684197-147B-4A4D-BF27-26EDDEC3B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7D178B-B06F-432E-9BD6-BAEC38F28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423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12CFC-6859-42DA-ADD9-3A0749084D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9A3BA3-1E79-4482-9F2C-AE57BA27B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3BEA10-BF5E-4D9B-BB80-3025DE9D3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A4C182-E0C5-42D2-96D6-2CD24DAC5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850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4CEEF7-80D7-4EA7-9732-43096B384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65BA75-3EFB-44AE-BF75-1D67C3506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46EED2-C2FE-4187-96F3-97738B95B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19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3DE90E-C2F7-4C62-AC07-094D0AFB6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5CB6C8-37E1-446F-B78E-D25C95005D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49C2BF-EC0A-4649-9C1B-B8049E8E5F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BFE5F6-3F32-4AA8-81F9-FF7CB264C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F5CC4E-EEDA-4FF3-AF2F-ECD32D3A6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327282-1346-4808-A24C-DC1D807D0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647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36997-8DC1-425F-ABEB-8C142F443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9A34C5-ABDA-447E-BD39-05AEB5342C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1018B3-FFE9-4573-9722-776985925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EE55B9-FB92-4592-9C78-9BB8F8F1F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78142E-0B27-4D86-8EBA-8A20B3F0B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889C6F-4F41-4190-8548-96B1FE784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837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A7CFED-F1CF-499D-AA17-0D8F82033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6574E3-9F1C-4BF7-8977-AD0C67C05E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A86274-3786-468D-9B6A-6EA7CB9926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E81BA-680A-41D6-843F-826FC359EEFE}" type="datetimeFigureOut">
              <a:rPr lang="en-US" smtClean="0"/>
              <a:t>11-Aug-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333749-6C13-4986-8D55-BBEDE1E4ED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63C0C5-74AC-45FC-A38F-D2FD23D793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9C052-1E7B-4ED1-8432-6330BFCFCB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596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microsoft.com/office/2007/relationships/media" Target="../media/media3.mp4"/><Relationship Id="rId1" Type="http://schemas.openxmlformats.org/officeDocument/2006/relationships/video" Target="NULL" TargetMode="Externa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69BFDE7-764B-4FCE-B9C5-9F587D3C4EB6}"/>
              </a:ext>
            </a:extLst>
          </p:cNvPr>
          <p:cNvSpPr txBox="1"/>
          <p:nvPr/>
        </p:nvSpPr>
        <p:spPr>
          <a:xfrm>
            <a:off x="337930" y="2455651"/>
            <a:ext cx="22263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icrobubble formation without an electric field </a:t>
            </a:r>
          </a:p>
          <a:p>
            <a:endParaRPr lang="en-US" dirty="0"/>
          </a:p>
        </p:txBody>
      </p:sp>
      <p:pic>
        <p:nvPicPr>
          <p:cNvPr id="5" name="8kVACDC">
            <a:hlinkClick r:id="" action="ppaction://media"/>
            <a:extLst>
              <a:ext uri="{FF2B5EF4-FFF2-40B4-BE49-F238E27FC236}">
                <a16:creationId xmlns:a16="http://schemas.microsoft.com/office/drawing/2014/main" id="{71C5D027-F91F-4EE0-8A98-DC93C64C694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r="27867" b="965"/>
          <a:stretch/>
        </p:blipFill>
        <p:spPr>
          <a:xfrm>
            <a:off x="2564297" y="423586"/>
            <a:ext cx="7652127" cy="580621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FA2F9CA-D6A5-4323-8A84-2503F32CEBF5}"/>
              </a:ext>
            </a:extLst>
          </p:cNvPr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75" t="33321" r="799"/>
          <a:stretch/>
        </p:blipFill>
        <p:spPr bwMode="auto">
          <a:xfrm>
            <a:off x="9678705" y="3331326"/>
            <a:ext cx="1075436" cy="310308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0477957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199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DC only 6kV DC">
            <a:hlinkClick r:id="" action="ppaction://media"/>
            <a:extLst>
              <a:ext uri="{FF2B5EF4-FFF2-40B4-BE49-F238E27FC236}">
                <a16:creationId xmlns:a16="http://schemas.microsoft.com/office/drawing/2014/main" id="{7AE3BEF9-A976-43AC-9671-85BC9F92FBA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-1" r="28262" b="608"/>
          <a:stretch/>
        </p:blipFill>
        <p:spPr>
          <a:xfrm>
            <a:off x="1166192" y="126552"/>
            <a:ext cx="8746434" cy="64202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F214B77-BADF-4A17-8804-6C9625101D46}"/>
              </a:ext>
            </a:extLst>
          </p:cNvPr>
          <p:cNvSpPr txBox="1"/>
          <p:nvPr/>
        </p:nvSpPr>
        <p:spPr>
          <a:xfrm>
            <a:off x="384312" y="2967335"/>
            <a:ext cx="3697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kV DC field only, No AC</a:t>
            </a:r>
          </a:p>
        </p:txBody>
      </p:sp>
    </p:spTree>
    <p:extLst>
      <p:ext uri="{BB962C8B-B14F-4D97-AF65-F5344CB8AC3E}">
        <p14:creationId xmlns:p14="http://schemas.microsoft.com/office/powerpoint/2010/main" val="21931558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27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uperimposed AC on DC">
            <a:hlinkClick r:id="" action="ppaction://media"/>
            <a:extLst>
              <a:ext uri="{FF2B5EF4-FFF2-40B4-BE49-F238E27FC236}">
                <a16:creationId xmlns:a16="http://schemas.microsoft.com/office/drawing/2014/main" id="{094FC5A4-D8BD-452D-8768-AA81C24E0B3F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7656"/>
                </p14:media>
              </p:ext>
            </p:extLst>
          </p:nvPr>
        </p:nvPicPr>
        <p:blipFill rotWithShape="1">
          <a:blip r:embed="rId4"/>
          <a:srcRect l="7173" r="26363" b="3583"/>
          <a:stretch>
            <a:fillRect/>
          </a:stretch>
        </p:blipFill>
        <p:spPr>
          <a:xfrm>
            <a:off x="1954695" y="146344"/>
            <a:ext cx="8282610" cy="671165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B556DB6-A59A-437E-9FFA-87CDCAAD9E83}"/>
              </a:ext>
            </a:extLst>
          </p:cNvPr>
          <p:cNvSpPr txBox="1"/>
          <p:nvPr/>
        </p:nvSpPr>
        <p:spPr>
          <a:xfrm>
            <a:off x="795130" y="2464904"/>
            <a:ext cx="36973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kV AC P-P superimposed on 6kV DC, 2kHz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9781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74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2</Words>
  <Application>Microsoft Office PowerPoint</Application>
  <PresentationFormat>Widescreen</PresentationFormat>
  <Paragraphs>3</Paragraphs>
  <Slides>3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na</dc:creator>
  <cp:lastModifiedBy>Anjana</cp:lastModifiedBy>
  <cp:revision>5</cp:revision>
  <dcterms:created xsi:type="dcterms:W3CDTF">2018-08-11T11:32:29Z</dcterms:created>
  <dcterms:modified xsi:type="dcterms:W3CDTF">2018-08-11T12:05:12Z</dcterms:modified>
</cp:coreProperties>
</file>